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3">
  <p:sldMasterIdLst>
    <p:sldMasterId id="2147483648" r:id="rId1"/>
  </p:sldMasterIdLst>
  <p:notesMasterIdLst>
    <p:notesMasterId r:id="rId16"/>
  </p:notesMasterIdLst>
  <p:sldIdLst>
    <p:sldId id="283" r:id="rId2"/>
    <p:sldId id="274" r:id="rId3"/>
    <p:sldId id="309" r:id="rId4"/>
    <p:sldId id="263" r:id="rId5"/>
    <p:sldId id="284" r:id="rId6"/>
    <p:sldId id="310" r:id="rId7"/>
    <p:sldId id="267" r:id="rId8"/>
    <p:sldId id="279" r:id="rId9"/>
    <p:sldId id="256" r:id="rId10"/>
    <p:sldId id="307" r:id="rId11"/>
    <p:sldId id="308" r:id="rId12"/>
    <p:sldId id="257" r:id="rId13"/>
    <p:sldId id="304" r:id="rId14"/>
    <p:sldId id="305" r:id="rId15"/>
  </p:sldIdLst>
  <p:sldSz cx="12192000" cy="6858000"/>
  <p:notesSz cx="6858000" cy="9144000"/>
  <p:custDataLst>
    <p:tags r:id="rId1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3093"/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9"/>
    <p:restoredTop sz="94697"/>
  </p:normalViewPr>
  <p:slideViewPr>
    <p:cSldViewPr snapToGrid="0">
      <p:cViewPr varScale="1">
        <p:scale>
          <a:sx n="83" d="100"/>
          <a:sy n="83" d="100"/>
        </p:scale>
        <p:origin x="408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gs" Target="tags/tag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image" Target="../media/image26.emf"/><Relationship Id="rId6" Type="http://schemas.openxmlformats.org/officeDocument/2006/relationships/image" Target="../media/image31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F17CD5-5BD6-BF45-B412-4EB11CE2ACE8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87FD24-0C6A-AA43-AB2A-EFD794CF6E0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87FD24-0C6A-AA43-AB2A-EFD794CF6E0A}" type="slidenum">
              <a:rPr lang="en-US" smtClean="0"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87FD24-0C6A-AA43-AB2A-EFD794CF6E0A}" type="slidenum">
              <a:rPr lang="en-US" smtClean="0"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87FD24-0C6A-AA43-AB2A-EFD794CF6E0A}" type="slidenum">
              <a:rPr lang="en-US" smtClean="0"/>
              <a:t>7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6CD22-86C1-4132-B6DE-6929E8BEE6F0}" type="datetimeFigureOut">
              <a:rPr lang="zh-CN" altLang="en-US" smtClean="0"/>
              <a:t>2023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DF739-8CBD-4ADC-8DF4-426EEEA0C30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Relationship Id="rId9" Type="http://schemas.openxmlformats.org/officeDocument/2006/relationships/image" Target="../media/image73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png"/><Relationship Id="rId3" Type="http://schemas.openxmlformats.org/officeDocument/2006/relationships/image" Target="../media/image75.png"/><Relationship Id="rId7" Type="http://schemas.openxmlformats.org/officeDocument/2006/relationships/image" Target="../media/image79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4" Type="http://schemas.openxmlformats.org/officeDocument/2006/relationships/image" Target="../media/image76.png"/><Relationship Id="rId9" Type="http://schemas.openxmlformats.org/officeDocument/2006/relationships/image" Target="../media/image81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5" Type="http://schemas.openxmlformats.org/officeDocument/2006/relationships/image" Target="../media/image85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6.png"/><Relationship Id="rId3" Type="http://schemas.openxmlformats.org/officeDocument/2006/relationships/image" Target="../media/image91.png"/><Relationship Id="rId7" Type="http://schemas.openxmlformats.org/officeDocument/2006/relationships/image" Target="../media/image95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4.png"/><Relationship Id="rId5" Type="http://schemas.openxmlformats.org/officeDocument/2006/relationships/image" Target="../media/image93.png"/><Relationship Id="rId4" Type="http://schemas.openxmlformats.org/officeDocument/2006/relationships/image" Target="../media/image92.png"/><Relationship Id="rId9" Type="http://schemas.openxmlformats.org/officeDocument/2006/relationships/image" Target="../media/image9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emf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0" Type="http://schemas.openxmlformats.org/officeDocument/2006/relationships/image" Target="../media/image22.emf"/><Relationship Id="rId4" Type="http://schemas.openxmlformats.org/officeDocument/2006/relationships/image" Target="../media/image16.png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3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30.emf"/><Relationship Id="rId17" Type="http://schemas.openxmlformats.org/officeDocument/2006/relationships/image" Target="../media/image34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3.emf"/><Relationship Id="rId20" Type="http://schemas.openxmlformats.org/officeDocument/2006/relationships/image" Target="../media/image37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7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32.emf"/><Relationship Id="rId10" Type="http://schemas.openxmlformats.org/officeDocument/2006/relationships/image" Target="../media/image29.emf"/><Relationship Id="rId19" Type="http://schemas.openxmlformats.org/officeDocument/2006/relationships/image" Target="../media/image36.png"/><Relationship Id="rId4" Type="http://schemas.openxmlformats.org/officeDocument/2006/relationships/image" Target="../media/image26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3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0.png"/><Relationship Id="rId5" Type="http://schemas.openxmlformats.org/officeDocument/2006/relationships/image" Target="../media/image38.emf"/><Relationship Id="rId4" Type="http://schemas.openxmlformats.org/officeDocument/2006/relationships/oleObject" Target="../embeddings/oleObject7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emf"/><Relationship Id="rId7" Type="http://schemas.openxmlformats.org/officeDocument/2006/relationships/image" Target="../media/image4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0" Type="http://schemas.openxmlformats.org/officeDocument/2006/relationships/image" Target="../media/image48.png"/><Relationship Id="rId4" Type="http://schemas.openxmlformats.org/officeDocument/2006/relationships/image" Target="../media/image42.emf"/><Relationship Id="rId9" Type="http://schemas.openxmlformats.org/officeDocument/2006/relationships/image" Target="../media/image4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7.emf"/><Relationship Id="rId4" Type="http://schemas.openxmlformats.org/officeDocument/2006/relationships/image" Target="../media/image5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494878" y="681458"/>
            <a:ext cx="7045154" cy="5495084"/>
            <a:chOff x="2494878" y="681458"/>
            <a:chExt cx="7045154" cy="5495084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0109" y="1718299"/>
              <a:ext cx="3722088" cy="1892498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7445" y="783351"/>
              <a:ext cx="3483795" cy="934948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2494878" y="681458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6619251" y="681458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7586188" y="3711422"/>
              <a:ext cx="1953844" cy="2465120"/>
              <a:chOff x="5750556" y="3645142"/>
              <a:chExt cx="1953844" cy="2465120"/>
            </a:xfrm>
          </p:grpSpPr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50556" y="3645142"/>
                <a:ext cx="1856757" cy="2231936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6249403" y="5833263"/>
                <a:ext cx="14549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02-edited</a:t>
                </a:r>
              </a:p>
            </p:txBody>
          </p:sp>
        </p:grpSp>
        <p:sp>
          <p:nvSpPr>
            <p:cNvPr id="23" name="文本框 22"/>
            <p:cNvSpPr txBox="1"/>
            <p:nvPr/>
          </p:nvSpPr>
          <p:spPr>
            <a:xfrm>
              <a:off x="2495455" y="3711422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6619250" y="3711422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" name="图片 3">
            <a:extLst>
              <a:ext uri="{FF2B5EF4-FFF2-40B4-BE49-F238E27FC236}">
                <a16:creationId xmlns:a16="http://schemas.microsoft.com/office/drawing/2014/main" id="{077E5713-D372-48D6-999B-0077396F15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651406"/>
            <a:ext cx="3700593" cy="213378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2687363-4D71-42B3-9600-6A77793C9B3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73112" y="4278306"/>
            <a:ext cx="3432345" cy="1280271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214341" y="778712"/>
            <a:ext cx="9763317" cy="5300576"/>
            <a:chOff x="978664" y="658543"/>
            <a:chExt cx="9763317" cy="5300576"/>
          </a:xfrm>
        </p:grpSpPr>
        <p:sp>
          <p:nvSpPr>
            <p:cNvPr id="77" name="文本框 76"/>
            <p:cNvSpPr txBox="1"/>
            <p:nvPr/>
          </p:nvSpPr>
          <p:spPr>
            <a:xfrm>
              <a:off x="978664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2913550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398952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8803076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978664" y="311312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2913550" y="311312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5398952" y="311226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8803076" y="311226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08103" y="988568"/>
              <a:ext cx="2381595" cy="2202491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52441" y="1027875"/>
              <a:ext cx="3555180" cy="2165689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061110" y="988568"/>
              <a:ext cx="1563500" cy="2419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17357" y="3666942"/>
              <a:ext cx="2381595" cy="2162659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52441" y="3664709"/>
              <a:ext cx="3608669" cy="2167123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114599" y="3537420"/>
              <a:ext cx="1627382" cy="2421699"/>
            </a:xfrm>
            <a:prstGeom prst="rect">
              <a:avLst/>
            </a:prstGeom>
          </p:spPr>
        </p:pic>
      </p:grpSp>
      <p:sp>
        <p:nvSpPr>
          <p:cNvPr id="18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5117A07-8E5E-4FFB-AD88-F5ECF26471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83461" y="1478070"/>
            <a:ext cx="1999775" cy="115629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65ABD18-4AD1-492B-B884-174A503CDEF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83461" y="4240595"/>
            <a:ext cx="1969573" cy="1156294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251159" y="945798"/>
            <a:ext cx="9689681" cy="4966403"/>
            <a:chOff x="978664" y="658543"/>
            <a:chExt cx="9689681" cy="4966403"/>
          </a:xfrm>
        </p:grpSpPr>
        <p:sp>
          <p:nvSpPr>
            <p:cNvPr id="77" name="文本框 76"/>
            <p:cNvSpPr txBox="1"/>
            <p:nvPr/>
          </p:nvSpPr>
          <p:spPr>
            <a:xfrm>
              <a:off x="978664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2913550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398952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8803076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978664" y="311312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2913550" y="311312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5398952" y="311226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8803076" y="311226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66267" y="1046428"/>
              <a:ext cx="2344481" cy="2250504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87351" y="1045574"/>
              <a:ext cx="3501995" cy="2051168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18546" y="918177"/>
              <a:ext cx="1401387" cy="2305961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42870" y="3481598"/>
              <a:ext cx="2344481" cy="2128789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95633" y="3535792"/>
              <a:ext cx="3501996" cy="2089154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118546" y="3318698"/>
              <a:ext cx="1549799" cy="2306248"/>
            </a:xfrm>
            <a:prstGeom prst="rect">
              <a:avLst/>
            </a:prstGeom>
          </p:spPr>
        </p:pic>
      </p:grpSp>
      <p:sp>
        <p:nvSpPr>
          <p:cNvPr id="18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1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2BA4D26-2461-4EBE-B644-C666A59A3F9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98034" y="1392099"/>
            <a:ext cx="2200847" cy="152413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5E6CFFD-4203-48C5-9D76-4685ADED958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67185" y="3952665"/>
            <a:ext cx="1971577" cy="1400856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385524" y="915913"/>
            <a:ext cx="9420951" cy="5026174"/>
            <a:chOff x="978664" y="658543"/>
            <a:chExt cx="9420951" cy="5026174"/>
          </a:xfrm>
        </p:grpSpPr>
        <p:sp>
          <p:nvSpPr>
            <p:cNvPr id="77" name="文本框 76"/>
            <p:cNvSpPr txBox="1"/>
            <p:nvPr/>
          </p:nvSpPr>
          <p:spPr>
            <a:xfrm>
              <a:off x="978664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2913550" y="65939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398952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8803076" y="658543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90321" y="916086"/>
              <a:ext cx="2388678" cy="1896769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45892" y="1074165"/>
              <a:ext cx="3294854" cy="1804526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978526" y="965730"/>
              <a:ext cx="1358895" cy="2146536"/>
            </a:xfrm>
            <a:prstGeom prst="rect">
              <a:avLst/>
            </a:prstGeom>
          </p:spPr>
        </p:pic>
        <p:sp>
          <p:nvSpPr>
            <p:cNvPr id="93" name="文本框 92"/>
            <p:cNvSpPr txBox="1"/>
            <p:nvPr/>
          </p:nvSpPr>
          <p:spPr>
            <a:xfrm>
              <a:off x="978664" y="3234419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2913550" y="3234419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5398952" y="3233565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/>
            <p:cNvSpPr txBox="1"/>
            <p:nvPr/>
          </p:nvSpPr>
          <p:spPr>
            <a:xfrm>
              <a:off x="8803076" y="3233565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90321" y="3783229"/>
              <a:ext cx="2308631" cy="1789506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78999" y="3781009"/>
              <a:ext cx="3499527" cy="1903708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024820" y="3479944"/>
              <a:ext cx="1374795" cy="2146535"/>
            </a:xfrm>
            <a:prstGeom prst="rect">
              <a:avLst/>
            </a:prstGeom>
          </p:spPr>
        </p:pic>
      </p:grpSp>
      <p:sp>
        <p:nvSpPr>
          <p:cNvPr id="19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AB300805-8577-4BC0-A360-7B0AF8BD901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85524" y="1424164"/>
            <a:ext cx="2216873" cy="135929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6BC78DA-FCE5-4E06-9274-76ACA5BD587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70916" y="4196746"/>
            <a:ext cx="2126265" cy="1290155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1365175" y="842996"/>
            <a:ext cx="9461649" cy="5172007"/>
            <a:chOff x="952031" y="1116557"/>
            <a:chExt cx="9461649" cy="5172007"/>
          </a:xfrm>
        </p:grpSpPr>
        <p:sp>
          <p:nvSpPr>
            <p:cNvPr id="2" name="文本框 1"/>
            <p:cNvSpPr txBox="1"/>
            <p:nvPr/>
          </p:nvSpPr>
          <p:spPr>
            <a:xfrm>
              <a:off x="952031" y="111655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2886917" y="116774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5372319" y="116774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8776443" y="118534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19621" y="1458484"/>
              <a:ext cx="2566059" cy="2038459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66569" y="1505537"/>
              <a:ext cx="3524374" cy="1932721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990943" y="1458484"/>
              <a:ext cx="1422737" cy="2245053"/>
            </a:xfrm>
            <a:prstGeom prst="rect">
              <a:avLst/>
            </a:prstGeom>
          </p:spPr>
        </p:pic>
        <p:sp>
          <p:nvSpPr>
            <p:cNvPr id="10" name="文本框 9"/>
            <p:cNvSpPr txBox="1"/>
            <p:nvPr/>
          </p:nvSpPr>
          <p:spPr>
            <a:xfrm>
              <a:off x="952031" y="3668169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886917" y="3719358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372319" y="3719358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8776443" y="3736952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19621" y="4106925"/>
              <a:ext cx="2480377" cy="1915814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66569" y="4202759"/>
              <a:ext cx="3524374" cy="1915814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990943" y="4062451"/>
              <a:ext cx="1422737" cy="2226113"/>
            </a:xfrm>
            <a:prstGeom prst="rect">
              <a:avLst/>
            </a:prstGeom>
          </p:spPr>
        </p:pic>
      </p:grpSp>
      <p:sp>
        <p:nvSpPr>
          <p:cNvPr id="22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3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CFADED5C-7071-4996-8559-BE10C4F59C8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65175" y="1473792"/>
            <a:ext cx="2134945" cy="131083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8085D1C7-475B-4432-9E78-FE15E15BACB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28388" y="3986355"/>
            <a:ext cx="2071732" cy="1264847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316434" y="949447"/>
            <a:ext cx="9559131" cy="4959106"/>
            <a:chOff x="952031" y="1116557"/>
            <a:chExt cx="9559131" cy="4959106"/>
          </a:xfrm>
        </p:grpSpPr>
        <p:sp>
          <p:nvSpPr>
            <p:cNvPr id="2" name="文本框 1"/>
            <p:cNvSpPr txBox="1"/>
            <p:nvPr/>
          </p:nvSpPr>
          <p:spPr>
            <a:xfrm>
              <a:off x="952031" y="111655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2886917" y="116774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5372319" y="1167746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8776443" y="118534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952031" y="3668169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886917" y="3719358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372319" y="3719358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8776443" y="3736952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26451" y="1485888"/>
              <a:ext cx="2540421" cy="2012829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66872" y="1562262"/>
              <a:ext cx="3408246" cy="1866738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65549" y="1514780"/>
              <a:ext cx="1345612" cy="212391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026450" y="4106284"/>
              <a:ext cx="2540422" cy="1963494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66872" y="4106284"/>
              <a:ext cx="3404124" cy="1851131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165549" y="3968130"/>
              <a:ext cx="1345613" cy="2107533"/>
            </a:xfrm>
            <a:prstGeom prst="rect">
              <a:avLst/>
            </a:prstGeom>
          </p:spPr>
        </p:pic>
      </p:grpSp>
      <p:sp>
        <p:nvSpPr>
          <p:cNvPr id="18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3A83D64-2C7F-4AAE-BA13-CBD984425C7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22840" y="1442712"/>
            <a:ext cx="2049737" cy="146178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2FFDF05-B20B-4B3F-ACC4-1CC60203845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83271" y="4091032"/>
            <a:ext cx="1990461" cy="140687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356562" y="1182310"/>
            <a:ext cx="9478876" cy="4493380"/>
            <a:chOff x="1543405" y="1392278"/>
            <a:chExt cx="9478876" cy="4493380"/>
          </a:xfrm>
        </p:grpSpPr>
        <p:sp>
          <p:nvSpPr>
            <p:cNvPr id="17" name="文本框 16"/>
            <p:cNvSpPr txBox="1"/>
            <p:nvPr/>
          </p:nvSpPr>
          <p:spPr>
            <a:xfrm>
              <a:off x="3783740" y="1392278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543405" y="3409470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810481" y="3458457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543406" y="1392278"/>
              <a:ext cx="4151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25624" y="1485224"/>
              <a:ext cx="6681795" cy="2249619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52365" y="3643123"/>
              <a:ext cx="6769916" cy="2242535"/>
            </a:xfrm>
            <a:prstGeom prst="rect">
              <a:avLst/>
            </a:prstGeom>
          </p:spPr>
        </p:pic>
      </p:grpSp>
      <p:pic>
        <p:nvPicPr>
          <p:cNvPr id="3" name="图片 2">
            <a:extLst>
              <a:ext uri="{FF2B5EF4-FFF2-40B4-BE49-F238E27FC236}">
                <a16:creationId xmlns:a16="http://schemas.microsoft.com/office/drawing/2014/main" id="{7282E9FD-1DD2-4128-9098-34806B5BCF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85332" y="1775171"/>
            <a:ext cx="2219136" cy="124978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1888410-00C0-4F4D-AE00-FD80EC6B8C1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60946" y="3895997"/>
            <a:ext cx="2243522" cy="131685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700145" y="104394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459865" y="306070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726815" y="310959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459865" y="104394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2780" y="1076325"/>
            <a:ext cx="6061075" cy="188214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10380" y="3245485"/>
            <a:ext cx="6421755" cy="2568575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110BB21F-1597-42D6-9A1A-4B25547C73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9136" y="1154497"/>
            <a:ext cx="2188654" cy="142049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AEFFBF1-4719-41B4-BCC1-C79E3C9E64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70686" y="3413231"/>
            <a:ext cx="1975275" cy="1713124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文本框 90"/>
          <p:cNvSpPr txBox="1"/>
          <p:nvPr/>
        </p:nvSpPr>
        <p:spPr>
          <a:xfrm>
            <a:off x="1606550" y="71628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5097145" y="73977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8792845" y="69278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1606550" y="353504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5097145" y="353504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8792845" y="353504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6400" y="4292600"/>
            <a:ext cx="1136015" cy="1632585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77030" y="4227195"/>
            <a:ext cx="1136015" cy="1668145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4665" y="4323080"/>
            <a:ext cx="1136015" cy="1629410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55595" y="1370330"/>
            <a:ext cx="1283970" cy="178943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17010" y="1332230"/>
            <a:ext cx="1292860" cy="1809115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15770" y="1376680"/>
            <a:ext cx="1259840" cy="174752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208135" y="4029075"/>
            <a:ext cx="1377315" cy="197358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77960" y="1191895"/>
            <a:ext cx="1417320" cy="197612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84695" y="1160780"/>
            <a:ext cx="1931670" cy="19805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050405" y="3854450"/>
            <a:ext cx="1643380" cy="2310130"/>
          </a:xfrm>
          <a:prstGeom prst="rect">
            <a:avLst/>
          </a:prstGeom>
        </p:spPr>
      </p:pic>
      <p:sp>
        <p:nvSpPr>
          <p:cNvPr id="59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474E6907-B69F-444B-B77F-4CF9286EDFF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54320" y="3986326"/>
            <a:ext cx="1846614" cy="167172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D5B7EC76-A7EA-4234-BF0C-BA887DF6CF2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305808" y="1376680"/>
            <a:ext cx="1744597" cy="1508041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2769235" y="1264920"/>
          <a:ext cx="1242695" cy="17329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4" name="Prism 6" r:id="rId3" imgW="1933575" imgH="2695575" progId="Prism6.Document">
                  <p:embed/>
                </p:oleObj>
              </mc:Choice>
              <mc:Fallback>
                <p:oleObj name="Prism 6" r:id="rId3" imgW="1933575" imgH="2695575" progId="Prism6.Document">
                  <p:embed/>
                  <p:pic>
                    <p:nvPicPr>
                      <p:cNvPr id="0" name="对象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69235" y="1264920"/>
                        <a:ext cx="1242695" cy="17329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3904615" y="1249045"/>
          <a:ext cx="1242695" cy="17379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5" name="Prism 6" r:id="rId5" imgW="1933575" imgH="2705100" progId="Prism6.Document">
                  <p:embed/>
                </p:oleObj>
              </mc:Choice>
              <mc:Fallback>
                <p:oleObj name="Prism 6" r:id="rId5" imgW="1933575" imgH="2705100" progId="Prism6.Document">
                  <p:embed/>
                  <p:pic>
                    <p:nvPicPr>
                      <p:cNvPr id="0" name="对象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04615" y="1249045"/>
                        <a:ext cx="1242695" cy="17379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/>
        </p:nvGraphicFramePr>
        <p:xfrm>
          <a:off x="1652905" y="1279525"/>
          <a:ext cx="1249045" cy="17329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6" name="Prism 6" r:id="rId7" imgW="1943100" imgH="2695575" progId="Prism6.Document">
                  <p:embed/>
                </p:oleObj>
              </mc:Choice>
              <mc:Fallback>
                <p:oleObj name="Prism 6" r:id="rId7" imgW="1943100" imgH="2695575" progId="Prism6.Document">
                  <p:embed/>
                  <p:pic>
                    <p:nvPicPr>
                      <p:cNvPr id="0" name="对象 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52905" y="1279525"/>
                        <a:ext cx="1249045" cy="17329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/>
        </p:nvGraphicFramePr>
        <p:xfrm>
          <a:off x="2764790" y="4008755"/>
          <a:ext cx="1250950" cy="17278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7" name="Prism 6" r:id="rId9" imgW="2047875" imgH="2819400" progId="Prism6.Document">
                  <p:embed/>
                </p:oleObj>
              </mc:Choice>
              <mc:Fallback>
                <p:oleObj name="Prism 6" r:id="rId9" imgW="2047875" imgH="2819400" progId="Prism6.Document">
                  <p:embed/>
                  <p:pic>
                    <p:nvPicPr>
                      <p:cNvPr id="0" name="对象 1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764790" y="4008755"/>
                        <a:ext cx="1250950" cy="17278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/>
        </p:nvGraphicFramePr>
        <p:xfrm>
          <a:off x="3900805" y="3983355"/>
          <a:ext cx="1250950" cy="17329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8" name="Prism 6" r:id="rId11" imgW="2047875" imgH="2828925" progId="Prism6.Document">
                  <p:embed/>
                </p:oleObj>
              </mc:Choice>
              <mc:Fallback>
                <p:oleObj name="Prism 6" r:id="rId11" imgW="2047875" imgH="2828925" progId="Prism6.Document">
                  <p:embed/>
                  <p:pic>
                    <p:nvPicPr>
                      <p:cNvPr id="0" name="对象 1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900805" y="3983355"/>
                        <a:ext cx="1250950" cy="17329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/>
        </p:nvGraphicFramePr>
        <p:xfrm>
          <a:off x="1647825" y="4011295"/>
          <a:ext cx="1189990" cy="17278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9" name="Prism 6" r:id="rId13" imgW="1943100" imgH="2819400" progId="Prism6.Document">
                  <p:embed/>
                </p:oleObj>
              </mc:Choice>
              <mc:Fallback>
                <p:oleObj name="Prism 6" r:id="rId13" imgW="1943100" imgH="2819400" progId="Prism6.Document">
                  <p:embed/>
                  <p:pic>
                    <p:nvPicPr>
                      <p:cNvPr id="0" name="对象 1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47825" y="4011295"/>
                        <a:ext cx="1189990" cy="17278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图片 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887210" y="1007110"/>
            <a:ext cx="1995170" cy="204597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888480" y="3687445"/>
            <a:ext cx="1599565" cy="224853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956040" y="1083310"/>
            <a:ext cx="1556385" cy="216916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007475" y="3801745"/>
            <a:ext cx="1599565" cy="233235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584960" y="72453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075555" y="74803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771255" y="701040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584960" y="354393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075555" y="354393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8771255" y="3543935"/>
            <a:ext cx="415290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D3F64EB-5F14-4A80-BA87-03DCBFA0B3E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148192" y="1117600"/>
            <a:ext cx="1905130" cy="173291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4B3197C-C427-45E5-BD83-B0E8412B93D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237408" y="3620698"/>
            <a:ext cx="1761634" cy="199898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845626" y="2443506"/>
            <a:ext cx="8531567" cy="1848828"/>
            <a:chOff x="2198636" y="1761257"/>
            <a:chExt cx="8531567" cy="1848828"/>
          </a:xfrm>
        </p:grpSpPr>
        <p:pic>
          <p:nvPicPr>
            <p:cNvPr id="3" name="图片 2" descr="venn_result358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59846" y="2006369"/>
              <a:ext cx="1590546" cy="1603716"/>
            </a:xfrm>
            <a:prstGeom prst="rect">
              <a:avLst/>
            </a:prstGeom>
          </p:spPr>
        </p:pic>
        <p:graphicFrame>
          <p:nvGraphicFramePr>
            <p:cNvPr id="4" name="对象 3"/>
            <p:cNvGraphicFramePr/>
            <p:nvPr/>
          </p:nvGraphicFramePr>
          <p:xfrm>
            <a:off x="7222576" y="2271429"/>
            <a:ext cx="3507627" cy="10735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9" r:id="rId4" imgW="4019550" imgH="923925" progId="Excel.Sheet.12">
                    <p:embed/>
                  </p:oleObj>
                </mc:Choice>
                <mc:Fallback>
                  <p:oleObj r:id="rId4" imgW="4019550" imgH="923925" progId="Excel.Sheet.12">
                    <p:embed/>
                    <p:pic>
                      <p:nvPicPr>
                        <p:cNvPr id="0" name="对象 152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7222576" y="2271429"/>
                          <a:ext cx="3507627" cy="10735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文本框 5"/>
            <p:cNvSpPr txBox="1"/>
            <p:nvPr/>
          </p:nvSpPr>
          <p:spPr>
            <a:xfrm>
              <a:off x="2198636" y="1761257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5218363" y="1761257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" name="图片 8">
            <a:extLst>
              <a:ext uri="{FF2B5EF4-FFF2-40B4-BE49-F238E27FC236}">
                <a16:creationId xmlns:a16="http://schemas.microsoft.com/office/drawing/2014/main" id="{119301B4-0FDE-48EF-9549-FF93D278738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51453" y="2766282"/>
            <a:ext cx="3040499" cy="152605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1" name="组合 40"/>
          <p:cNvGrpSpPr/>
          <p:nvPr/>
        </p:nvGrpSpPr>
        <p:grpSpPr>
          <a:xfrm>
            <a:off x="1413851" y="623492"/>
            <a:ext cx="7303672" cy="4698490"/>
            <a:chOff x="1420877" y="623492"/>
            <a:chExt cx="7303672" cy="4698490"/>
          </a:xfrm>
        </p:grpSpPr>
        <p:sp>
          <p:nvSpPr>
            <p:cNvPr id="7" name="文本框 6"/>
            <p:cNvSpPr txBox="1"/>
            <p:nvPr/>
          </p:nvSpPr>
          <p:spPr>
            <a:xfrm>
              <a:off x="1420877" y="623492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3143649" y="668549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5859344" y="668549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8309406" y="623492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1420878" y="2779402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3143650" y="2824292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文本框 145"/>
            <p:cNvSpPr txBox="1"/>
            <p:nvPr/>
          </p:nvSpPr>
          <p:spPr>
            <a:xfrm>
              <a:off x="5919868" y="2668523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文本框 146"/>
            <p:cNvSpPr txBox="1"/>
            <p:nvPr/>
          </p:nvSpPr>
          <p:spPr>
            <a:xfrm>
              <a:off x="8309405" y="2668523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文本框 147"/>
            <p:cNvSpPr txBox="1"/>
            <p:nvPr/>
          </p:nvSpPr>
          <p:spPr>
            <a:xfrm>
              <a:off x="1420878" y="4921872"/>
              <a:ext cx="4151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00396" y="674214"/>
              <a:ext cx="1349033" cy="2241661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28133" y="2824292"/>
              <a:ext cx="1447935" cy="2235668"/>
            </a:xfrm>
            <a:prstGeom prst="rect">
              <a:avLst/>
            </a:prstGeom>
          </p:spPr>
        </p:pic>
      </p:grpSp>
      <p:pic>
        <p:nvPicPr>
          <p:cNvPr id="2" name="图片 1">
            <a:extLst>
              <a:ext uri="{FF2B5EF4-FFF2-40B4-BE49-F238E27FC236}">
                <a16:creationId xmlns:a16="http://schemas.microsoft.com/office/drawing/2014/main" id="{3ABF398D-633D-411E-AA24-EDC284E151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82816" y="988734"/>
            <a:ext cx="2586039" cy="15745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CED6040-0ECF-440C-99D5-002858B83B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61315" y="3024347"/>
            <a:ext cx="2465758" cy="157458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B56141D-C530-4A42-9816-DB2E7F7F90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76279" y="1091354"/>
            <a:ext cx="2483359" cy="98323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CF70C7F-1C40-4DD8-BF7C-2877DB5BF4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27073" y="3068633"/>
            <a:ext cx="2483359" cy="97880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6510F3E6-78B0-4EE4-8118-ED54835CBD6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09950" y="1091354"/>
            <a:ext cx="2561895" cy="110033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5A655D1-18D5-4B19-9FF7-85516733825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88486" y="2978394"/>
            <a:ext cx="2561895" cy="113414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22FB585-ABF2-4D23-95C4-F3F611F9C74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00403" y="5149262"/>
            <a:ext cx="4395597" cy="1146147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81"/>
          <p:cNvSpPr txBox="1"/>
          <p:nvPr/>
        </p:nvSpPr>
        <p:spPr>
          <a:xfrm>
            <a:off x="6276134" y="582588"/>
            <a:ext cx="415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2964226" y="582588"/>
            <a:ext cx="415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2963304" y="3378405"/>
            <a:ext cx="46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132"/>
          <p:cNvSpPr txBox="1"/>
          <p:nvPr/>
        </p:nvSpPr>
        <p:spPr>
          <a:xfrm>
            <a:off x="6248721" y="3373712"/>
            <a:ext cx="468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DCBCAF5-8399-4CF6-997B-DF2C3CDBD7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0550" y="844558"/>
            <a:ext cx="2778935" cy="230395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EE32E55-43FD-4987-8BB1-C681436F20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0367" y="853442"/>
            <a:ext cx="2918176" cy="234119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D7D6DE7-62E2-4FB4-86B8-FB9582B486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81948" y="3585186"/>
            <a:ext cx="2847758" cy="237597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A0D73E4-7E49-4204-A17D-D5B910AAC6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83041" y="3429000"/>
            <a:ext cx="3018689" cy="2587448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699221" y="656862"/>
            <a:ext cx="6793557" cy="5544275"/>
            <a:chOff x="1810070" y="854640"/>
            <a:chExt cx="6793557" cy="5544275"/>
          </a:xfrm>
        </p:grpSpPr>
        <p:sp>
          <p:nvSpPr>
            <p:cNvPr id="6" name="文本框 5"/>
            <p:cNvSpPr txBox="1"/>
            <p:nvPr/>
          </p:nvSpPr>
          <p:spPr>
            <a:xfrm>
              <a:off x="1810070" y="85464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5349221" y="854640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810070" y="3571967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5349221" y="3565709"/>
              <a:ext cx="3891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47241" y="990367"/>
              <a:ext cx="3053915" cy="2549005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95306" y="3727772"/>
              <a:ext cx="3053915" cy="2549006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29877" y="854640"/>
              <a:ext cx="2351989" cy="2689119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96000" y="3605634"/>
              <a:ext cx="2507627" cy="2793281"/>
            </a:xfrm>
            <a:prstGeom prst="rect">
              <a:avLst/>
            </a:prstGeom>
          </p:spPr>
        </p:pic>
      </p:grpSp>
      <p:sp>
        <p:nvSpPr>
          <p:cNvPr id="19" name="文本框 11"/>
          <p:cNvSpPr txBox="1"/>
          <p:nvPr/>
        </p:nvSpPr>
        <p:spPr>
          <a:xfrm>
            <a:off x="11022281" y="6336558"/>
            <a:ext cx="1169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8e607770-3e8f-4a6b-9927-f7c8178f4108"/>
  <p:tag name="COMMONDATA" val="eyJoZGlkIjoiYmNhOGNiMzhkZGU3ZTNiNzQ5NWNhMmEwM2IxM2NhYWY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2</TotalTime>
  <Words>115</Words>
  <Application>Microsoft Office PowerPoint</Application>
  <PresentationFormat>宽屏</PresentationFormat>
  <Paragraphs>101</Paragraphs>
  <Slides>14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4</vt:i4>
      </vt:variant>
    </vt:vector>
  </HeadingPairs>
  <TitlesOfParts>
    <vt:vector size="22" baseType="lpstr">
      <vt:lpstr>等线</vt:lpstr>
      <vt:lpstr>等线 Light</vt:lpstr>
      <vt:lpstr>Arial</vt:lpstr>
      <vt:lpstr>Calibri</vt:lpstr>
      <vt:lpstr>Times New Roman</vt:lpstr>
      <vt:lpstr>Office 主题​​</vt:lpstr>
      <vt:lpstr>Prism 6</vt:lpstr>
      <vt:lpstr>Microsoft Excel Workshee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BIN</dc:creator>
  <cp:lastModifiedBy>Zhangbin</cp:lastModifiedBy>
  <cp:revision>327</cp:revision>
  <dcterms:created xsi:type="dcterms:W3CDTF">2021-07-11T04:18:00Z</dcterms:created>
  <dcterms:modified xsi:type="dcterms:W3CDTF">2023-06-05T10:03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8886C7B50E644C6A4EB48CB60F7458E</vt:lpwstr>
  </property>
  <property fmtid="{D5CDD505-2E9C-101B-9397-08002B2CF9AE}" pid="3" name="KSOProductBuildVer">
    <vt:lpwstr>2052-11.1.0.13703</vt:lpwstr>
  </property>
</Properties>
</file>